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8CEB49-B554-4367-A4FF-6EDC5D80D6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DC5C89-5101-43B0-957F-F95DC9C5BE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90F8C-444D-40AD-9A01-00786C53451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014C4C-CC11-42CE-99DD-A5D4E467F26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772364-BA6B-4498-9A1F-9EB1DBBB60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C71397-5D29-4B96-B11C-26493869F7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A1CE93-D8FF-41BE-8042-5EFA638205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2731AC-46C1-4B38-B11C-D69826EC30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A8E314-7506-4BE3-A5E7-339BDFAA35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C8200-5B89-43B9-911B-982A368369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1CED05-FD13-4EF7-86DC-F3D7FD8A5D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36CAD6-4C96-4DF3-88F8-8DB16E6F3E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9835D5-9481-4531-B962-30DAB66D720E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50920" y="155520"/>
            <a:ext cx="8605800" cy="652644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990960" y="49320"/>
            <a:ext cx="5076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</a:rPr>
              <a:t>Additional data file 4 - Interaction subnetworks involved in Cd-specific sensitivity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Previously identified subnetworks expanded with respect to co-sensitive mutants (Fig. 2) and newly identified, Cd-specific subnetworks are encircled in red and blue, respectively. See Fig. 2 and Additional data file 3 legends for further details.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07T16:53:20Z</dcterms:created>
  <dc:creator>Roberta</dc:creator>
  <dc:description/>
  <dc:language>en-US</dc:language>
  <cp:lastModifiedBy>Dipartimento di Biochimica e Biologia Molecolare</cp:lastModifiedBy>
  <dcterms:modified xsi:type="dcterms:W3CDTF">2008-04-04T15:07:50Z</dcterms:modified>
  <cp:revision>28</cp:revision>
  <dc:subject/>
  <dc:title>Diapositiva 1</dc:title>
</cp:coreProperties>
</file>